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100" d="100"/>
          <a:sy n="100" d="100"/>
        </p:scale>
        <p:origin x="756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KUBOTA\Desktop\&#22522;&#30990;&#23455;&#39443;\CyD\CyD%20(PLoS%20ONE)\Revise\Cell%20Cycle%20(revise).xlsx" TargetMode="External"/><Relationship Id="rId1" Type="http://schemas.openxmlformats.org/officeDocument/2006/relationships/themeOverride" Target="../theme/themeOverrid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NALM-6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NALM6 cell cycle'!$I$3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LM6 cell cycle'!$J$7:$L$7</c:f>
                <c:numCache>
                  <c:formatCode>General</c:formatCode>
                  <c:ptCount val="3"/>
                  <c:pt idx="0">
                    <c:v>1.4571661996262923</c:v>
                  </c:pt>
                  <c:pt idx="1">
                    <c:v>1.5695009822658066</c:v>
                  </c:pt>
                  <c:pt idx="2">
                    <c:v>2.5514701644345905</c:v>
                  </c:pt>
                </c:numCache>
              </c:numRef>
            </c:plus>
            <c:minus>
              <c:numRef>
                <c:f>'NALM6 cell cycle'!$J$7:$L$7</c:f>
                <c:numCache>
                  <c:formatCode>General</c:formatCode>
                  <c:ptCount val="3"/>
                  <c:pt idx="0">
                    <c:v>1.4571661996262923</c:v>
                  </c:pt>
                  <c:pt idx="1">
                    <c:v>1.5695009822658066</c:v>
                  </c:pt>
                  <c:pt idx="2">
                    <c:v>2.5514701644345905</c:v>
                  </c:pt>
                </c:numCache>
              </c:numRef>
            </c:minus>
            <c:spPr>
              <a:ln w="12700"/>
            </c:spPr>
          </c:errBars>
          <c:cat>
            <c:numRef>
              <c:f>'NALM6 cell cycle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NALM6 cell cycle'!$J$3:$L$3</c:f>
              <c:numCache>
                <c:formatCode>General</c:formatCode>
                <c:ptCount val="3"/>
                <c:pt idx="0">
                  <c:v>41.933333333333337</c:v>
                </c:pt>
                <c:pt idx="1">
                  <c:v>40.733333333333334</c:v>
                </c:pt>
                <c:pt idx="2">
                  <c:v>18.8</c:v>
                </c:pt>
              </c:numCache>
            </c:numRef>
          </c:val>
        </c:ser>
        <c:ser>
          <c:idx val="1"/>
          <c:order val="1"/>
          <c:tx>
            <c:strRef>
              <c:f>'NALM6 cell cycle'!$I$4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LM6 cell cycle'!$J$8:$L$8</c:f>
                <c:numCache>
                  <c:formatCode>General</c:formatCode>
                  <c:ptCount val="3"/>
                  <c:pt idx="0">
                    <c:v>3.0022213997860541</c:v>
                  </c:pt>
                  <c:pt idx="1">
                    <c:v>1.311487704860397</c:v>
                  </c:pt>
                  <c:pt idx="2">
                    <c:v>3.9357337308308833</c:v>
                  </c:pt>
                </c:numCache>
              </c:numRef>
            </c:plus>
            <c:minus>
              <c:numRef>
                <c:f>'NALM6 cell cycle'!$J$8:$L$8</c:f>
                <c:numCache>
                  <c:formatCode>General</c:formatCode>
                  <c:ptCount val="3"/>
                  <c:pt idx="0">
                    <c:v>3.0022213997860541</c:v>
                  </c:pt>
                  <c:pt idx="1">
                    <c:v>1.311487704860397</c:v>
                  </c:pt>
                  <c:pt idx="2">
                    <c:v>3.9357337308308833</c:v>
                  </c:pt>
                </c:numCache>
              </c:numRef>
            </c:minus>
            <c:spPr>
              <a:ln w="12700"/>
            </c:spPr>
          </c:errBars>
          <c:cat>
            <c:numRef>
              <c:f>'NALM6 cell cycle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NALM6 cell cycle'!$J$4:$L$4</c:f>
              <c:numCache>
                <c:formatCode>General</c:formatCode>
                <c:ptCount val="3"/>
                <c:pt idx="0">
                  <c:v>38.56666666666667</c:v>
                </c:pt>
                <c:pt idx="1">
                  <c:v>36.4</c:v>
                </c:pt>
                <c:pt idx="2">
                  <c:v>35.9</c:v>
                </c:pt>
              </c:numCache>
            </c:numRef>
          </c:val>
        </c:ser>
        <c:ser>
          <c:idx val="2"/>
          <c:order val="2"/>
          <c:tx>
            <c:strRef>
              <c:f>'NALM6 cell cycle'!$I$5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NALM6 cell cycle'!$J$9:$L$9</c:f>
                <c:numCache>
                  <c:formatCode>General</c:formatCode>
                  <c:ptCount val="3"/>
                  <c:pt idx="0">
                    <c:v>1.2124355652982135</c:v>
                  </c:pt>
                  <c:pt idx="1">
                    <c:v>0.83266639978645207</c:v>
                  </c:pt>
                  <c:pt idx="2">
                    <c:v>0.72341781380702352</c:v>
                  </c:pt>
                </c:numCache>
              </c:numRef>
            </c:plus>
            <c:minus>
              <c:numRef>
                <c:f>'NALM6 cell cycle'!$J$9:$L$9</c:f>
                <c:numCache>
                  <c:formatCode>General</c:formatCode>
                  <c:ptCount val="3"/>
                  <c:pt idx="0">
                    <c:v>1.2124355652982135</c:v>
                  </c:pt>
                  <c:pt idx="1">
                    <c:v>0.83266639978645207</c:v>
                  </c:pt>
                  <c:pt idx="2">
                    <c:v>0.72341781380702352</c:v>
                  </c:pt>
                </c:numCache>
              </c:numRef>
            </c:minus>
            <c:spPr>
              <a:ln w="12700"/>
            </c:spPr>
          </c:errBars>
          <c:cat>
            <c:numRef>
              <c:f>'NALM6 cell cycle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NALM6 cell cycle'!$J$5:$L$5</c:f>
              <c:numCache>
                <c:formatCode>General</c:formatCode>
                <c:ptCount val="3"/>
                <c:pt idx="0">
                  <c:v>16.3</c:v>
                </c:pt>
                <c:pt idx="1">
                  <c:v>17.733333333333331</c:v>
                </c:pt>
                <c:pt idx="2">
                  <c:v>29.66666666666666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671704"/>
        <c:axId val="52136320"/>
      </c:barChart>
      <c:catAx>
        <c:axId val="170671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 baseline="0"/>
            </a:pPr>
            <a:endParaRPr lang="ja-JP"/>
          </a:p>
        </c:txPr>
        <c:crossAx val="52136320"/>
        <c:crosses val="autoZero"/>
        <c:auto val="1"/>
        <c:lblAlgn val="ctr"/>
        <c:lblOffset val="100"/>
        <c:noMultiLvlLbl val="0"/>
      </c:catAx>
      <c:valAx>
        <c:axId val="521363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 baseline="0"/>
            </a:pPr>
            <a:endParaRPr lang="ja-JP"/>
          </a:p>
        </c:txPr>
        <c:crossAx val="170671704"/>
        <c:crosses val="autoZero"/>
        <c:crossBetween val="between"/>
        <c:majorUnit val="10"/>
      </c:valAx>
    </c:plotArea>
    <c:legend>
      <c:legendPos val="r"/>
      <c:layout/>
      <c:overlay val="0"/>
      <c:txPr>
        <a:bodyPr/>
        <a:lstStyle/>
        <a:p>
          <a:pPr>
            <a:defRPr sz="1200" baseline="0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Jurkat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Jurkat!$I$2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Jurkat!$J$7:$L$7</c:f>
                <c:numCache>
                  <c:formatCode>General</c:formatCode>
                  <c:ptCount val="3"/>
                  <c:pt idx="0">
                    <c:v>2.7465129406819355</c:v>
                  </c:pt>
                  <c:pt idx="1">
                    <c:v>2.9569128044860111</c:v>
                  </c:pt>
                  <c:pt idx="2">
                    <c:v>0.95393920141694488</c:v>
                  </c:pt>
                </c:numCache>
              </c:numRef>
            </c:plus>
            <c:minus>
              <c:numRef>
                <c:f>Jurkat!$J$7:$L$7</c:f>
                <c:numCache>
                  <c:formatCode>General</c:formatCode>
                  <c:ptCount val="3"/>
                  <c:pt idx="0">
                    <c:v>2.7465129406819355</c:v>
                  </c:pt>
                  <c:pt idx="1">
                    <c:v>2.9569128044860111</c:v>
                  </c:pt>
                  <c:pt idx="2">
                    <c:v>0.95393920141694488</c:v>
                  </c:pt>
                </c:numCache>
              </c:numRef>
            </c:minus>
          </c:errBars>
          <c:cat>
            <c:numRef>
              <c:f>Jurkat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Jurkat!$J$2:$L$2</c:f>
              <c:numCache>
                <c:formatCode>General</c:formatCode>
                <c:ptCount val="3"/>
                <c:pt idx="0">
                  <c:v>45.166666666666664</c:v>
                </c:pt>
                <c:pt idx="1">
                  <c:v>46.233333333333327</c:v>
                </c:pt>
                <c:pt idx="2">
                  <c:v>21.400000000000002</c:v>
                </c:pt>
              </c:numCache>
            </c:numRef>
          </c:val>
        </c:ser>
        <c:ser>
          <c:idx val="1"/>
          <c:order val="1"/>
          <c:tx>
            <c:strRef>
              <c:f>Jurkat!$I$3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Jurkat!$J$8:$L$8</c:f>
                <c:numCache>
                  <c:formatCode>General</c:formatCode>
                  <c:ptCount val="3"/>
                  <c:pt idx="0">
                    <c:v>4.0926763859361976</c:v>
                  </c:pt>
                  <c:pt idx="1">
                    <c:v>2.8148416178061115</c:v>
                  </c:pt>
                  <c:pt idx="2">
                    <c:v>0.15275252316519683</c:v>
                  </c:pt>
                </c:numCache>
              </c:numRef>
            </c:plus>
            <c:minus>
              <c:numRef>
                <c:f>Jurkat!$J$8:$L$8</c:f>
                <c:numCache>
                  <c:formatCode>General</c:formatCode>
                  <c:ptCount val="3"/>
                  <c:pt idx="0">
                    <c:v>4.0926763859361976</c:v>
                  </c:pt>
                  <c:pt idx="1">
                    <c:v>2.8148416178061115</c:v>
                  </c:pt>
                  <c:pt idx="2">
                    <c:v>0.15275252316519683</c:v>
                  </c:pt>
                </c:numCache>
              </c:numRef>
            </c:minus>
          </c:errBars>
          <c:cat>
            <c:numRef>
              <c:f>Jurkat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Jurkat!$J$3:$L$3</c:f>
              <c:numCache>
                <c:formatCode>General</c:formatCode>
                <c:ptCount val="3"/>
                <c:pt idx="0">
                  <c:v>33.1</c:v>
                </c:pt>
                <c:pt idx="1">
                  <c:v>32.266666666666673</c:v>
                </c:pt>
                <c:pt idx="2">
                  <c:v>34.06666666666667</c:v>
                </c:pt>
              </c:numCache>
            </c:numRef>
          </c:val>
        </c:ser>
        <c:ser>
          <c:idx val="2"/>
          <c:order val="2"/>
          <c:tx>
            <c:strRef>
              <c:f>Jurkat!$I$4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Jurkat!$J$9:$L$9</c:f>
                <c:numCache>
                  <c:formatCode>General</c:formatCode>
                  <c:ptCount val="3"/>
                  <c:pt idx="0">
                    <c:v>1.5099668870541498</c:v>
                  </c:pt>
                  <c:pt idx="1">
                    <c:v>0.45825756949558411</c:v>
                  </c:pt>
                  <c:pt idx="2">
                    <c:v>0.28284271247462051</c:v>
                  </c:pt>
                </c:numCache>
              </c:numRef>
            </c:plus>
            <c:minus>
              <c:numRef>
                <c:f>Jurkat!$J$9:$L$9</c:f>
                <c:numCache>
                  <c:formatCode>General</c:formatCode>
                  <c:ptCount val="3"/>
                  <c:pt idx="0">
                    <c:v>1.5099668870541498</c:v>
                  </c:pt>
                  <c:pt idx="1">
                    <c:v>0.45825756949558411</c:v>
                  </c:pt>
                  <c:pt idx="2">
                    <c:v>0.28284271247462051</c:v>
                  </c:pt>
                </c:numCache>
              </c:numRef>
            </c:minus>
          </c:errBars>
          <c:cat>
            <c:numRef>
              <c:f>Jurkat!$J$1:$L$1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Jurkat!$J$4:$L$4</c:f>
              <c:numCache>
                <c:formatCode>General</c:formatCode>
                <c:ptCount val="3"/>
                <c:pt idx="0">
                  <c:v>15.1</c:v>
                </c:pt>
                <c:pt idx="1">
                  <c:v>14.5</c:v>
                </c:pt>
                <c:pt idx="2">
                  <c:v>29.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69373408"/>
        <c:axId val="170937408"/>
      </c:barChart>
      <c:catAx>
        <c:axId val="1693734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170937408"/>
        <c:crosses val="autoZero"/>
        <c:auto val="1"/>
        <c:lblAlgn val="ctr"/>
        <c:lblOffset val="100"/>
        <c:noMultiLvlLbl val="0"/>
      </c:catAx>
      <c:valAx>
        <c:axId val="1709374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169373408"/>
        <c:crosses val="autoZero"/>
        <c:crossBetween val="between"/>
        <c:majorUnit val="10"/>
      </c:valAx>
    </c:plotArea>
    <c:legend>
      <c:legendPos val="r"/>
      <c:layout>
        <c:manualLayout>
          <c:xMode val="edge"/>
          <c:yMode val="edge"/>
          <c:x val="0.82108552055993"/>
          <c:y val="0.42100065616797899"/>
          <c:w val="0.13169225721784777"/>
          <c:h val="0.26772090988626424"/>
        </c:manualLayout>
      </c:layout>
      <c:overlay val="0"/>
      <c:txPr>
        <a:bodyPr/>
        <a:lstStyle/>
        <a:p>
          <a:pPr>
            <a:defRPr sz="1200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KBM5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'KBM5'!$I$3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KBM5'!$J$7:$L$7</c:f>
                <c:numCache>
                  <c:formatCode>General</c:formatCode>
                  <c:ptCount val="3"/>
                  <c:pt idx="0">
                    <c:v>1.7785762095938784</c:v>
                  </c:pt>
                  <c:pt idx="1">
                    <c:v>0.62449979983984072</c:v>
                  </c:pt>
                  <c:pt idx="2">
                    <c:v>0.8888194417315601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ln w="12700"/>
            </c:spPr>
          </c:errBars>
          <c:cat>
            <c:numRef>
              <c:f>'KBM5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KBM5'!$J$3:$L$3</c:f>
              <c:numCache>
                <c:formatCode>General</c:formatCode>
                <c:ptCount val="3"/>
                <c:pt idx="0">
                  <c:v>39.033333333333331</c:v>
                </c:pt>
                <c:pt idx="1">
                  <c:v>32.199999999999996</c:v>
                </c:pt>
                <c:pt idx="2">
                  <c:v>23.600000000000005</c:v>
                </c:pt>
              </c:numCache>
            </c:numRef>
          </c:val>
        </c:ser>
        <c:ser>
          <c:idx val="1"/>
          <c:order val="1"/>
          <c:tx>
            <c:strRef>
              <c:f>'KBM5'!$I$4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KBM5'!$J$8:$L$8</c:f>
                <c:numCache>
                  <c:formatCode>General</c:formatCode>
                  <c:ptCount val="3"/>
                  <c:pt idx="0">
                    <c:v>2.1733231083604072</c:v>
                  </c:pt>
                  <c:pt idx="1">
                    <c:v>1.6165807537309504</c:v>
                  </c:pt>
                  <c:pt idx="2">
                    <c:v>2.325940669922602</c:v>
                  </c:pt>
                </c:numCache>
              </c:numRef>
            </c:plus>
            <c:minus>
              <c:numRef>
                <c:f>'KBM5'!$J$8:$L$8</c:f>
                <c:numCache>
                  <c:formatCode>General</c:formatCode>
                  <c:ptCount val="3"/>
                  <c:pt idx="0">
                    <c:v>2.1733231083604072</c:v>
                  </c:pt>
                  <c:pt idx="1">
                    <c:v>1.6165807537309504</c:v>
                  </c:pt>
                  <c:pt idx="2">
                    <c:v>2.325940669922602</c:v>
                  </c:pt>
                </c:numCache>
              </c:numRef>
            </c:minus>
            <c:spPr>
              <a:ln w="12700"/>
            </c:spPr>
          </c:errBars>
          <c:cat>
            <c:numRef>
              <c:f>'KBM5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KBM5'!$J$4:$L$4</c:f>
              <c:numCache>
                <c:formatCode>General</c:formatCode>
                <c:ptCount val="3"/>
                <c:pt idx="0">
                  <c:v>37.133333333333333</c:v>
                </c:pt>
                <c:pt idx="1">
                  <c:v>39.133333333333333</c:v>
                </c:pt>
                <c:pt idx="2">
                  <c:v>36.4</c:v>
                </c:pt>
              </c:numCache>
            </c:numRef>
          </c:val>
        </c:ser>
        <c:ser>
          <c:idx val="2"/>
          <c:order val="2"/>
          <c:tx>
            <c:strRef>
              <c:f>'KBM5'!$I$5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KBM5'!$J$9:$L$9</c:f>
                <c:numCache>
                  <c:formatCode>General</c:formatCode>
                  <c:ptCount val="3"/>
                  <c:pt idx="0">
                    <c:v>1.7691806012954132</c:v>
                  </c:pt>
                  <c:pt idx="1">
                    <c:v>1.3576941236277542</c:v>
                  </c:pt>
                  <c:pt idx="2">
                    <c:v>1.9287301521985913</c:v>
                  </c:pt>
                </c:numCache>
              </c:numRef>
            </c:plus>
            <c:minus>
              <c:numRef>
                <c:f>'KBM5'!$J$9:$L$9</c:f>
                <c:numCache>
                  <c:formatCode>General</c:formatCode>
                  <c:ptCount val="3"/>
                  <c:pt idx="0">
                    <c:v>1.7691806012954132</c:v>
                  </c:pt>
                  <c:pt idx="1">
                    <c:v>1.3576941236277542</c:v>
                  </c:pt>
                  <c:pt idx="2">
                    <c:v>1.9287301521985913</c:v>
                  </c:pt>
                </c:numCache>
              </c:numRef>
            </c:minus>
            <c:spPr>
              <a:ln w="12700"/>
            </c:spPr>
          </c:errBars>
          <c:cat>
            <c:numRef>
              <c:f>'KBM5'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'KBM5'!$J$5:$L$5</c:f>
              <c:numCache>
                <c:formatCode>General</c:formatCode>
                <c:ptCount val="3"/>
                <c:pt idx="0">
                  <c:v>17.999999999999996</c:v>
                </c:pt>
                <c:pt idx="1">
                  <c:v>21.233333333333334</c:v>
                </c:pt>
                <c:pt idx="2">
                  <c:v>32.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489008"/>
        <c:axId val="170489392"/>
      </c:barChart>
      <c:catAx>
        <c:axId val="1704890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170489392"/>
        <c:crosses val="autoZero"/>
        <c:auto val="1"/>
        <c:lblAlgn val="ctr"/>
        <c:lblOffset val="100"/>
        <c:noMultiLvlLbl val="0"/>
      </c:catAx>
      <c:valAx>
        <c:axId val="170489392"/>
        <c:scaling>
          <c:orientation val="minMax"/>
          <c:max val="5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ja-JP"/>
          </a:p>
        </c:txPr>
        <c:crossAx val="170489008"/>
        <c:crosses val="autoZero"/>
        <c:crossBetween val="between"/>
        <c:majorUnit val="10"/>
      </c:valAx>
    </c:plotArea>
    <c:legend>
      <c:legendPos val="r"/>
      <c:layout/>
      <c:overlay val="0"/>
      <c:txPr>
        <a:bodyPr/>
        <a:lstStyle/>
        <a:p>
          <a:pPr>
            <a:defRPr sz="1200">
              <a:latin typeface="Arial" panose="020B0604020202020204" pitchFamily="34" charset="0"/>
              <a:cs typeface="Arial" panose="020B0604020202020204" pitchFamily="34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en-US"/>
              <a:t>MOLT-4</a:t>
            </a:r>
            <a:endParaRPr lang="ja-JP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MOLT4!$I$3</c:f>
              <c:strCache>
                <c:ptCount val="1"/>
                <c:pt idx="0">
                  <c:v>G1</c:v>
                </c:pt>
              </c:strCache>
            </c:strRef>
          </c:tx>
          <c:spPr>
            <a:solidFill>
              <a:schemeClr val="bg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OLT4!$J$7:$L$7</c:f>
                <c:numCache>
                  <c:formatCode>General</c:formatCode>
                  <c:ptCount val="3"/>
                  <c:pt idx="0">
                    <c:v>1.4730919862656227</c:v>
                  </c:pt>
                  <c:pt idx="1">
                    <c:v>5.1264022471905202</c:v>
                  </c:pt>
                  <c:pt idx="2">
                    <c:v>4.5081407845511539</c:v>
                  </c:pt>
                </c:numCache>
              </c:numRef>
            </c:plus>
            <c:minus>
              <c:numRef>
                <c:f>MOLT4!$J$7:$L$7</c:f>
                <c:numCache>
                  <c:formatCode>General</c:formatCode>
                  <c:ptCount val="3"/>
                  <c:pt idx="0">
                    <c:v>1.4730919862656227</c:v>
                  </c:pt>
                  <c:pt idx="1">
                    <c:v>5.1264022471905202</c:v>
                  </c:pt>
                  <c:pt idx="2">
                    <c:v>4.5081407845511539</c:v>
                  </c:pt>
                </c:numCache>
              </c:numRef>
            </c:minus>
            <c:spPr>
              <a:ln w="12700"/>
            </c:spPr>
          </c:errBars>
          <c:cat>
            <c:numRef>
              <c:f>MOLT4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MOLT4!$J$3:$L$3</c:f>
              <c:numCache>
                <c:formatCode>General</c:formatCode>
                <c:ptCount val="3"/>
                <c:pt idx="0">
                  <c:v>51.699999999999996</c:v>
                </c:pt>
                <c:pt idx="1">
                  <c:v>47.199999999999996</c:v>
                </c:pt>
                <c:pt idx="2">
                  <c:v>28.833333333333332</c:v>
                </c:pt>
              </c:numCache>
            </c:numRef>
          </c:val>
        </c:ser>
        <c:ser>
          <c:idx val="1"/>
          <c:order val="1"/>
          <c:tx>
            <c:strRef>
              <c:f>MOLT4!$I$4</c:f>
              <c:strCache>
                <c:ptCount val="1"/>
                <c:pt idx="0">
                  <c:v>S</c:v>
                </c:pt>
              </c:strCache>
            </c:strRef>
          </c:tx>
          <c:spPr>
            <a:solidFill>
              <a:schemeClr val="bg1">
                <a:lumMod val="75000"/>
              </a:schemeClr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OLT4!$J$8:$L$8</c:f>
                <c:numCache>
                  <c:formatCode>General</c:formatCode>
                  <c:ptCount val="3"/>
                  <c:pt idx="0">
                    <c:v>1.5534906930308063</c:v>
                  </c:pt>
                  <c:pt idx="1">
                    <c:v>3.2695565448543626</c:v>
                  </c:pt>
                  <c:pt idx="2">
                    <c:v>4.1186567389542601</c:v>
                  </c:pt>
                </c:numCache>
              </c:numRef>
            </c:plus>
            <c:minus>
              <c:numRef>
                <c:f>MOLT4!$J$8:$L$8</c:f>
                <c:numCache>
                  <c:formatCode>General</c:formatCode>
                  <c:ptCount val="3"/>
                  <c:pt idx="0">
                    <c:v>1.5534906930308063</c:v>
                  </c:pt>
                  <c:pt idx="1">
                    <c:v>3.2695565448543626</c:v>
                  </c:pt>
                  <c:pt idx="2">
                    <c:v>4.1186567389542601</c:v>
                  </c:pt>
                </c:numCache>
              </c:numRef>
            </c:minus>
            <c:spPr>
              <a:ln w="12700"/>
            </c:spPr>
          </c:errBars>
          <c:cat>
            <c:numRef>
              <c:f>MOLT4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MOLT4!$J$4:$L$4</c:f>
              <c:numCache>
                <c:formatCode>General</c:formatCode>
                <c:ptCount val="3"/>
                <c:pt idx="0">
                  <c:v>29.366666666666664</c:v>
                </c:pt>
                <c:pt idx="1">
                  <c:v>32.800000000000004</c:v>
                </c:pt>
                <c:pt idx="2">
                  <c:v>39.866666666666667</c:v>
                </c:pt>
              </c:numCache>
            </c:numRef>
          </c:val>
        </c:ser>
        <c:ser>
          <c:idx val="2"/>
          <c:order val="2"/>
          <c:tx>
            <c:strRef>
              <c:f>MOLT4!$I$5</c:f>
              <c:strCache>
                <c:ptCount val="1"/>
                <c:pt idx="0">
                  <c:v>G2/M</c:v>
                </c:pt>
              </c:strCache>
            </c:strRef>
          </c:tx>
          <c:spPr>
            <a:solidFill>
              <a:schemeClr val="tx1"/>
            </a:solidFill>
            <a:ln w="12700"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MOLT4!$J$9:$L$9</c:f>
                <c:numCache>
                  <c:formatCode>General</c:formatCode>
                  <c:ptCount val="3"/>
                  <c:pt idx="0">
                    <c:v>0.5102940328869231</c:v>
                  </c:pt>
                  <c:pt idx="1">
                    <c:v>0.98595131725659346</c:v>
                  </c:pt>
                  <c:pt idx="2">
                    <c:v>2.3713568549109887</c:v>
                  </c:pt>
                </c:numCache>
              </c:numRef>
            </c:plus>
            <c:minus>
              <c:numRef>
                <c:f>MOLT4!$J$9:$L$9</c:f>
                <c:numCache>
                  <c:formatCode>General</c:formatCode>
                  <c:ptCount val="3"/>
                  <c:pt idx="0">
                    <c:v>0.5102940328869231</c:v>
                  </c:pt>
                  <c:pt idx="1">
                    <c:v>0.98595131725659346</c:v>
                  </c:pt>
                  <c:pt idx="2">
                    <c:v>2.3713568549109887</c:v>
                  </c:pt>
                </c:numCache>
              </c:numRef>
            </c:minus>
            <c:spPr>
              <a:ln w="12700"/>
            </c:spPr>
          </c:errBars>
          <c:cat>
            <c:numRef>
              <c:f>MOLT4!$J$2:$L$2</c:f>
              <c:numCache>
                <c:formatCode>General</c:formatCode>
                <c:ptCount val="3"/>
                <c:pt idx="0">
                  <c:v>0</c:v>
                </c:pt>
                <c:pt idx="1">
                  <c:v>5</c:v>
                </c:pt>
                <c:pt idx="2">
                  <c:v>10</c:v>
                </c:pt>
              </c:numCache>
            </c:numRef>
          </c:cat>
          <c:val>
            <c:numRef>
              <c:f>MOLT4!$J$5:$L$5</c:f>
              <c:numCache>
                <c:formatCode>General</c:formatCode>
                <c:ptCount val="3"/>
                <c:pt idx="0">
                  <c:v>5.7899999999999991</c:v>
                </c:pt>
                <c:pt idx="1">
                  <c:v>5.4899999999999993</c:v>
                </c:pt>
                <c:pt idx="2">
                  <c:v>16.76666666666666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70544688"/>
        <c:axId val="170549168"/>
      </c:barChart>
      <c:catAx>
        <c:axId val="170544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 baseline="0"/>
            </a:pPr>
            <a:endParaRPr lang="ja-JP"/>
          </a:p>
        </c:txPr>
        <c:crossAx val="170549168"/>
        <c:crosses val="autoZero"/>
        <c:auto val="1"/>
        <c:lblAlgn val="ctr"/>
        <c:lblOffset val="100"/>
        <c:noMultiLvlLbl val="0"/>
      </c:catAx>
      <c:valAx>
        <c:axId val="17054916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ln w="25400">
            <a:solidFill>
              <a:schemeClr val="tx1"/>
            </a:solidFill>
          </a:ln>
        </c:spPr>
        <c:txPr>
          <a:bodyPr/>
          <a:lstStyle/>
          <a:p>
            <a:pPr>
              <a:defRPr sz="1200" b="1"/>
            </a:pPr>
            <a:endParaRPr lang="ja-JP"/>
          </a:p>
        </c:txPr>
        <c:crossAx val="170544688"/>
        <c:crosses val="autoZero"/>
        <c:crossBetween val="between"/>
      </c:valAx>
    </c:plotArea>
    <c:legend>
      <c:legendPos val="r"/>
      <c:layout/>
      <c:overlay val="0"/>
      <c:txPr>
        <a:bodyPr/>
        <a:lstStyle/>
        <a:p>
          <a:pPr>
            <a:defRPr sz="1200"/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4D6546-4097-4CEF-94AC-36A69CB47562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4327286-4FE0-4EE8-9F70-F56AFB95CB7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701417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4327286-4FE0-4EE8-9F70-F56AFB95CB7E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763373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09676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03652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802144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676287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556894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94425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566275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267374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076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828530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059830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A78448-FCB3-4907-803C-A01F3DCD26E6}" type="datetimeFigureOut">
              <a:rPr kumimoji="1" lang="ja-JP" altLang="en-US" smtClean="0"/>
              <a:t>2015/9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2E6C75-8CDF-44A8-81EE-AE8F5C4733A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74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08190022"/>
              </p:ext>
            </p:extLst>
          </p:nvPr>
        </p:nvGraphicFramePr>
        <p:xfrm>
          <a:off x="107504" y="476672"/>
          <a:ext cx="4605337" cy="277653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02034235"/>
              </p:ext>
            </p:extLst>
          </p:nvPr>
        </p:nvGraphicFramePr>
        <p:xfrm>
          <a:off x="108124" y="386104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2770780"/>
              </p:ext>
            </p:extLst>
          </p:nvPr>
        </p:nvGraphicFramePr>
        <p:xfrm>
          <a:off x="4572000" y="54868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483386495"/>
              </p:ext>
            </p:extLst>
          </p:nvPr>
        </p:nvGraphicFramePr>
        <p:xfrm>
          <a:off x="4572000" y="3861048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9" name="テキスト ボックス 8"/>
          <p:cNvSpPr txBox="1"/>
          <p:nvPr/>
        </p:nvSpPr>
        <p:spPr>
          <a:xfrm>
            <a:off x="1475656" y="3212976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5940152" y="3212976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1475656" y="6505599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5940152" y="6505599"/>
            <a:ext cx="1512168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HP-</a:t>
            </a:r>
            <a:r>
              <a:rPr kumimoji="1" lang="el-GR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yD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kumimoji="1" lang="en-US" altLang="ja-JP" sz="14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kumimoji="1" lang="en-US" altLang="ja-JP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107504" y="260648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535996" y="251356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107504" y="3573016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4572000" y="3573016"/>
            <a:ext cx="3960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b="1" dirty="0" smtClean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kumimoji="1" lang="ja-JP" alt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51520" y="631721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4716016" y="620688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251520" y="3933056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4716016" y="3944089"/>
            <a:ext cx="43204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%)</a:t>
            </a:r>
            <a:endParaRPr kumimoji="1" lang="ja-JP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91024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37</Words>
  <Application>Microsoft Office PowerPoint</Application>
  <PresentationFormat>画面に合わせる (4:3)</PresentationFormat>
  <Paragraphs>17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​​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YASUSHI KUBOTA</dc:creator>
  <cp:lastModifiedBy>久保田　寧</cp:lastModifiedBy>
  <cp:revision>4</cp:revision>
  <dcterms:created xsi:type="dcterms:W3CDTF">2015-07-28T11:44:17Z</dcterms:created>
  <dcterms:modified xsi:type="dcterms:W3CDTF">2015-09-26T09:44:43Z</dcterms:modified>
</cp:coreProperties>
</file>